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4" r:id="rId2"/>
  </p:sldIdLst>
  <p:sldSz cx="6119813" cy="79200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495" userDrawn="1">
          <p15:clr>
            <a:srgbClr val="A4A3A4"/>
          </p15:clr>
        </p15:guide>
        <p15:guide id="2" pos="192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101" d="100"/>
          <a:sy n="101" d="100"/>
        </p:scale>
        <p:origin x="2904" y="114"/>
      </p:cViewPr>
      <p:guideLst>
        <p:guide orient="horz" pos="2495"/>
        <p:guide pos="192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986" y="1296173"/>
            <a:ext cx="5201841" cy="2757347"/>
          </a:xfrm>
        </p:spPr>
        <p:txBody>
          <a:bodyPr anchor="b"/>
          <a:lstStyle>
            <a:lvl1pPr algn="ctr">
              <a:defRPr sz="401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4159854"/>
            <a:ext cx="4589860" cy="1912175"/>
          </a:xfrm>
        </p:spPr>
        <p:txBody>
          <a:bodyPr/>
          <a:lstStyle>
            <a:lvl1pPr marL="0" indent="0" algn="ctr">
              <a:buNone/>
              <a:defRPr sz="1606"/>
            </a:lvl1pPr>
            <a:lvl2pPr marL="306004" indent="0" algn="ctr">
              <a:buNone/>
              <a:defRPr sz="1339"/>
            </a:lvl2pPr>
            <a:lvl3pPr marL="612008" indent="0" algn="ctr">
              <a:buNone/>
              <a:defRPr sz="1205"/>
            </a:lvl3pPr>
            <a:lvl4pPr marL="918012" indent="0" algn="ctr">
              <a:buNone/>
              <a:defRPr sz="1071"/>
            </a:lvl4pPr>
            <a:lvl5pPr marL="1224016" indent="0" algn="ctr">
              <a:buNone/>
              <a:defRPr sz="1071"/>
            </a:lvl5pPr>
            <a:lvl6pPr marL="1530020" indent="0" algn="ctr">
              <a:buNone/>
              <a:defRPr sz="1071"/>
            </a:lvl6pPr>
            <a:lvl7pPr marL="1836024" indent="0" algn="ctr">
              <a:buNone/>
              <a:defRPr sz="1071"/>
            </a:lvl7pPr>
            <a:lvl8pPr marL="2142028" indent="0" algn="ctr">
              <a:buNone/>
              <a:defRPr sz="1071"/>
            </a:lvl8pPr>
            <a:lvl9pPr marL="2448032" indent="0" algn="ctr">
              <a:buNone/>
              <a:defRPr sz="1071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F8861-03AC-4AC1-81FD-0FCE426546B4}" type="datetimeFigureOut">
              <a:rPr lang="zh-CN" altLang="en-US" smtClean="0"/>
              <a:t>2023/3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D2430-5580-4D66-AB28-9589B4F8B8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906086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F8861-03AC-4AC1-81FD-0FCE426546B4}" type="datetimeFigureOut">
              <a:rPr lang="zh-CN" altLang="en-US" smtClean="0"/>
              <a:t>2023/3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D2430-5580-4D66-AB28-9589B4F8B8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90684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421669"/>
            <a:ext cx="1319585" cy="671186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8" y="421669"/>
            <a:ext cx="3882256" cy="6711866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F8861-03AC-4AC1-81FD-0FCE426546B4}" type="datetimeFigureOut">
              <a:rPr lang="zh-CN" altLang="en-US" smtClean="0"/>
              <a:t>2023/3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D2430-5580-4D66-AB28-9589B4F8B8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84120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F8861-03AC-4AC1-81FD-0FCE426546B4}" type="datetimeFigureOut">
              <a:rPr lang="zh-CN" altLang="en-US" smtClean="0"/>
              <a:t>2023/3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D2430-5580-4D66-AB28-9589B4F8B8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539880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1974512"/>
            <a:ext cx="5278339" cy="3294515"/>
          </a:xfrm>
        </p:spPr>
        <p:txBody>
          <a:bodyPr anchor="b"/>
          <a:lstStyle>
            <a:lvl1pPr>
              <a:defRPr sz="401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5300194"/>
            <a:ext cx="5278339" cy="1732508"/>
          </a:xfrm>
        </p:spPr>
        <p:txBody>
          <a:bodyPr/>
          <a:lstStyle>
            <a:lvl1pPr marL="0" indent="0">
              <a:buNone/>
              <a:defRPr sz="1606">
                <a:solidFill>
                  <a:schemeClr val="tx1"/>
                </a:solidFill>
              </a:defRPr>
            </a:lvl1pPr>
            <a:lvl2pPr marL="306004" indent="0">
              <a:buNone/>
              <a:defRPr sz="1339">
                <a:solidFill>
                  <a:schemeClr val="tx1">
                    <a:tint val="75000"/>
                  </a:schemeClr>
                </a:solidFill>
              </a:defRPr>
            </a:lvl2pPr>
            <a:lvl3pPr marL="612008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3pPr>
            <a:lvl4pPr marL="91801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4pPr>
            <a:lvl5pPr marL="1224016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5pPr>
            <a:lvl6pPr marL="1530020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6pPr>
            <a:lvl7pPr marL="1836024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7pPr>
            <a:lvl8pPr marL="2142028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8pPr>
            <a:lvl9pPr marL="244803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F8861-03AC-4AC1-81FD-0FCE426546B4}" type="datetimeFigureOut">
              <a:rPr lang="zh-CN" altLang="en-US" smtClean="0"/>
              <a:t>2023/3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D2430-5580-4D66-AB28-9589B4F8B8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69222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2108344"/>
            <a:ext cx="2600921" cy="5025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2108344"/>
            <a:ext cx="2600921" cy="5025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F8861-03AC-4AC1-81FD-0FCE426546B4}" type="datetimeFigureOut">
              <a:rPr lang="zh-CN" altLang="en-US" smtClean="0"/>
              <a:t>2023/3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D2430-5580-4D66-AB28-9589B4F8B8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895694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421671"/>
            <a:ext cx="5278339" cy="1530841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5" y="1941510"/>
            <a:ext cx="2588967" cy="951504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5" y="2893014"/>
            <a:ext cx="2588967" cy="42551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1941510"/>
            <a:ext cx="2601718" cy="951504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2893014"/>
            <a:ext cx="2601718" cy="42551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F8861-03AC-4AC1-81FD-0FCE426546B4}" type="datetimeFigureOut">
              <a:rPr lang="zh-CN" altLang="en-US" smtClean="0"/>
              <a:t>2023/3/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D2430-5580-4D66-AB28-9589B4F8B8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158019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F8861-03AC-4AC1-81FD-0FCE426546B4}" type="datetimeFigureOut">
              <a:rPr lang="zh-CN" altLang="en-US" smtClean="0"/>
              <a:t>2023/3/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D2430-5580-4D66-AB28-9589B4F8B8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517605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F8861-03AC-4AC1-81FD-0FCE426546B4}" type="datetimeFigureOut">
              <a:rPr lang="zh-CN" altLang="en-US" smtClean="0"/>
              <a:t>2023/3/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D2430-5580-4D66-AB28-9589B4F8B8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838618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28002"/>
            <a:ext cx="1973799" cy="1848009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1140341"/>
            <a:ext cx="3098155" cy="5628360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376011"/>
            <a:ext cx="1973799" cy="4401855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F8861-03AC-4AC1-81FD-0FCE426546B4}" type="datetimeFigureOut">
              <a:rPr lang="zh-CN" altLang="en-US" smtClean="0"/>
              <a:t>2023/3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D2430-5580-4D66-AB28-9589B4F8B8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445362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28002"/>
            <a:ext cx="1973799" cy="1848009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1140341"/>
            <a:ext cx="3098155" cy="5628360"/>
          </a:xfrm>
        </p:spPr>
        <p:txBody>
          <a:bodyPr anchor="t"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376011"/>
            <a:ext cx="1973799" cy="4401855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F8861-03AC-4AC1-81FD-0FCE426546B4}" type="datetimeFigureOut">
              <a:rPr lang="zh-CN" altLang="en-US" smtClean="0"/>
              <a:t>2023/3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D2430-5580-4D66-AB28-9589B4F8B8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902597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421671"/>
            <a:ext cx="5278339" cy="15308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2108344"/>
            <a:ext cx="5278339" cy="502519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7340703"/>
            <a:ext cx="1376958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4F8861-03AC-4AC1-81FD-0FCE426546B4}" type="datetimeFigureOut">
              <a:rPr lang="zh-CN" altLang="en-US" smtClean="0"/>
              <a:t>2023/3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7340703"/>
            <a:ext cx="2065437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7340703"/>
            <a:ext cx="1376958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CD2430-5580-4D66-AB28-9589B4F8B8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395956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12008" rtl="0" eaLnBrk="1" latinLnBrk="0" hangingPunct="1">
        <a:lnSpc>
          <a:spcPct val="90000"/>
        </a:lnSpc>
        <a:spcBef>
          <a:spcPct val="0"/>
        </a:spcBef>
        <a:buNone/>
        <a:defRPr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2" indent="-153002" algn="l" defTabSz="612008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900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image" Target="../media/image2.tiff"/><Relationship Id="rId7" Type="http://schemas.microsoft.com/office/2007/relationships/hdphoto" Target="../media/hdphoto2.wdp"/><Relationship Id="rId12" Type="http://schemas.openxmlformats.org/officeDocument/2006/relationships/image" Target="../media/image8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7.tiff"/><Relationship Id="rId5" Type="http://schemas.microsoft.com/office/2007/relationships/hdphoto" Target="../media/hdphoto1.wdp"/><Relationship Id="rId10" Type="http://schemas.openxmlformats.org/officeDocument/2006/relationships/image" Target="../media/image6.png"/><Relationship Id="rId4" Type="http://schemas.openxmlformats.org/officeDocument/2006/relationships/image" Target="../media/image3.png"/><Relationship Id="rId9" Type="http://schemas.microsoft.com/office/2007/relationships/hdphoto" Target="../media/hdphoto3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xmlns="" id="{1C31A05A-9A82-95B2-067F-F3C1369ACAF4}"/>
              </a:ext>
            </a:extLst>
          </p:cNvPr>
          <p:cNvGrpSpPr/>
          <p:nvPr/>
        </p:nvGrpSpPr>
        <p:grpSpPr>
          <a:xfrm>
            <a:off x="2272302" y="1117405"/>
            <a:ext cx="2181369" cy="1361400"/>
            <a:chOff x="6744402" y="2511696"/>
            <a:chExt cx="3877878" cy="2338668"/>
          </a:xfrm>
        </p:grpSpPr>
        <p:pic>
          <p:nvPicPr>
            <p:cNvPr id="3" name="图片 2">
              <a:extLst>
                <a:ext uri="{FF2B5EF4-FFF2-40B4-BE49-F238E27FC236}">
                  <a16:creationId xmlns:a16="http://schemas.microsoft.com/office/drawing/2014/main" xmlns="" id="{BADAD436-F15F-0A24-BD64-4341071A975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781" t="47131" r="61241" b="41628"/>
            <a:stretch/>
          </p:blipFill>
          <p:spPr>
            <a:xfrm>
              <a:off x="7814353" y="3826247"/>
              <a:ext cx="1380640" cy="547269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pic>
          <p:nvPicPr>
            <p:cNvPr id="4" name="图片 3">
              <a:extLst>
                <a:ext uri="{FF2B5EF4-FFF2-40B4-BE49-F238E27FC236}">
                  <a16:creationId xmlns:a16="http://schemas.microsoft.com/office/drawing/2014/main" xmlns="" id="{8DABA601-DBBF-285D-B225-A2A50072C04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277" t="41758" r="43817" b="46052"/>
            <a:stretch/>
          </p:blipFill>
          <p:spPr>
            <a:xfrm>
              <a:off x="7796778" y="2978115"/>
              <a:ext cx="1407972" cy="453556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xmlns="" id="{6CD96DCF-B189-B613-BAD4-D1FC1D50E396}"/>
                </a:ext>
              </a:extLst>
            </p:cNvPr>
            <p:cNvSpPr txBox="1"/>
            <p:nvPr/>
          </p:nvSpPr>
          <p:spPr>
            <a:xfrm>
              <a:off x="9342118" y="3874636"/>
              <a:ext cx="1148081" cy="358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56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α-Actin</a:t>
              </a:r>
              <a:endParaRPr lang="zh-CN" altLang="en-US" sz="756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xmlns="" id="{2C0AD362-1FD1-6543-9363-5982D8A1F6FB}"/>
                </a:ext>
              </a:extLst>
            </p:cNvPr>
            <p:cNvSpPr txBox="1"/>
            <p:nvPr/>
          </p:nvSpPr>
          <p:spPr>
            <a:xfrm>
              <a:off x="9342118" y="3042157"/>
              <a:ext cx="1280162" cy="358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56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α-Flag</a:t>
              </a:r>
              <a:endParaRPr lang="zh-CN" altLang="en-US" sz="756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xmlns="" id="{0275FA98-3A07-15BF-359D-E250BD3FB766}"/>
                </a:ext>
              </a:extLst>
            </p:cNvPr>
            <p:cNvSpPr txBox="1"/>
            <p:nvPr/>
          </p:nvSpPr>
          <p:spPr>
            <a:xfrm>
              <a:off x="7182827" y="2511696"/>
              <a:ext cx="629920" cy="358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56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</a:t>
              </a:r>
              <a:endParaRPr lang="zh-CN" altLang="en-US" sz="756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8" name="直接连接符 7">
              <a:extLst>
                <a:ext uri="{FF2B5EF4-FFF2-40B4-BE49-F238E27FC236}">
                  <a16:creationId xmlns:a16="http://schemas.microsoft.com/office/drawing/2014/main" xmlns="" id="{CDBB85E8-691B-36B4-000C-108D687FD039}"/>
                </a:ext>
              </a:extLst>
            </p:cNvPr>
            <p:cNvCxnSpPr/>
            <p:nvPr/>
          </p:nvCxnSpPr>
          <p:spPr>
            <a:xfrm>
              <a:off x="7551103" y="3153461"/>
              <a:ext cx="2348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" name="直接连接符 8">
              <a:extLst>
                <a:ext uri="{FF2B5EF4-FFF2-40B4-BE49-F238E27FC236}">
                  <a16:creationId xmlns:a16="http://schemas.microsoft.com/office/drawing/2014/main" xmlns="" id="{ADF6BFA1-B417-0AB8-DFFA-0549F4D18A55}"/>
                </a:ext>
              </a:extLst>
            </p:cNvPr>
            <p:cNvCxnSpPr/>
            <p:nvPr/>
          </p:nvCxnSpPr>
          <p:spPr>
            <a:xfrm>
              <a:off x="7579360" y="3932567"/>
              <a:ext cx="2348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" name="直接连接符 9">
              <a:extLst>
                <a:ext uri="{FF2B5EF4-FFF2-40B4-BE49-F238E27FC236}">
                  <a16:creationId xmlns:a16="http://schemas.microsoft.com/office/drawing/2014/main" xmlns="" id="{28DB7B3D-4768-3C57-2A1A-6D0DEF4196FC}"/>
                </a:ext>
              </a:extLst>
            </p:cNvPr>
            <p:cNvCxnSpPr/>
            <p:nvPr/>
          </p:nvCxnSpPr>
          <p:spPr>
            <a:xfrm>
              <a:off x="7579360" y="4247527"/>
              <a:ext cx="2348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" name="直接连接符 10">
              <a:extLst>
                <a:ext uri="{FF2B5EF4-FFF2-40B4-BE49-F238E27FC236}">
                  <a16:creationId xmlns:a16="http://schemas.microsoft.com/office/drawing/2014/main" xmlns="" id="{7EAD1846-15E2-4E3A-5F37-1B87C336F518}"/>
                </a:ext>
              </a:extLst>
            </p:cNvPr>
            <p:cNvCxnSpPr/>
            <p:nvPr/>
          </p:nvCxnSpPr>
          <p:spPr>
            <a:xfrm>
              <a:off x="7540942" y="3414407"/>
              <a:ext cx="2348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xmlns="" id="{88D0A93E-B22F-5C26-5AB4-86F50D396A20}"/>
                </a:ext>
              </a:extLst>
            </p:cNvPr>
            <p:cNvSpPr txBox="1"/>
            <p:nvPr/>
          </p:nvSpPr>
          <p:spPr>
            <a:xfrm>
              <a:off x="7228219" y="4067603"/>
              <a:ext cx="558802" cy="358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56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7</a:t>
              </a:r>
              <a:endParaRPr lang="zh-CN" altLang="en-US" sz="756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xmlns="" id="{3AA7F327-F468-6DC7-EF5F-64CF93B26AD6}"/>
                </a:ext>
              </a:extLst>
            </p:cNvPr>
            <p:cNvSpPr txBox="1"/>
            <p:nvPr/>
          </p:nvSpPr>
          <p:spPr>
            <a:xfrm>
              <a:off x="7228370" y="3759275"/>
              <a:ext cx="558802" cy="358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56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endParaRPr lang="zh-CN" altLang="en-US" sz="756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xmlns="" id="{D4876769-2DBD-7E8D-FF95-829E81CC2C7B}"/>
                </a:ext>
              </a:extLst>
            </p:cNvPr>
            <p:cNvSpPr txBox="1"/>
            <p:nvPr/>
          </p:nvSpPr>
          <p:spPr>
            <a:xfrm>
              <a:off x="7219921" y="3245956"/>
              <a:ext cx="558802" cy="358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56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7</a:t>
              </a:r>
              <a:endParaRPr lang="zh-CN" altLang="en-US" sz="756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xmlns="" id="{2287EC30-A43C-367B-07FB-1E77A16A05E1}"/>
                </a:ext>
              </a:extLst>
            </p:cNvPr>
            <p:cNvSpPr txBox="1"/>
            <p:nvPr/>
          </p:nvSpPr>
          <p:spPr>
            <a:xfrm>
              <a:off x="7179998" y="2956526"/>
              <a:ext cx="558802" cy="358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56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endParaRPr lang="zh-CN" altLang="en-US" sz="756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xmlns="" id="{F112D055-78AB-D336-D690-6021C70CE9BC}"/>
                </a:ext>
              </a:extLst>
            </p:cNvPr>
            <p:cNvSpPr txBox="1"/>
            <p:nvPr/>
          </p:nvSpPr>
          <p:spPr>
            <a:xfrm rot="19440000">
              <a:off x="6744402" y="4491942"/>
              <a:ext cx="2236471" cy="358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56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tBKI1-Flag  #17</a:t>
              </a:r>
              <a:endParaRPr lang="zh-CN" altLang="en-US" sz="756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xmlns="" id="{652552D1-36F2-154F-FB88-D4D1A1516941}"/>
                </a:ext>
              </a:extLst>
            </p:cNvPr>
            <p:cNvSpPr txBox="1"/>
            <p:nvPr/>
          </p:nvSpPr>
          <p:spPr>
            <a:xfrm rot="19440000">
              <a:off x="7308300" y="4439646"/>
              <a:ext cx="2236471" cy="358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56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tBKI1-Flag #15</a:t>
              </a:r>
              <a:endParaRPr lang="zh-CN" altLang="en-US" sz="756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xmlns="" id="{113B9A42-12F7-205D-1E6D-3BD27C3F0B01}"/>
                </a:ext>
              </a:extLst>
            </p:cNvPr>
            <p:cNvSpPr txBox="1"/>
            <p:nvPr/>
          </p:nvSpPr>
          <p:spPr>
            <a:xfrm rot="19440000">
              <a:off x="7767846" y="4453584"/>
              <a:ext cx="2236471" cy="358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56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tBKI1-Flag #11</a:t>
              </a:r>
              <a:endParaRPr lang="zh-CN" altLang="en-US" sz="756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6" name="组合 35">
            <a:extLst>
              <a:ext uri="{FF2B5EF4-FFF2-40B4-BE49-F238E27FC236}">
                <a16:creationId xmlns:a16="http://schemas.microsoft.com/office/drawing/2014/main" xmlns="" id="{B9DE4B14-6F0A-DFB2-6B08-A9C7F1F35B0A}"/>
              </a:ext>
            </a:extLst>
          </p:cNvPr>
          <p:cNvGrpSpPr/>
          <p:nvPr/>
        </p:nvGrpSpPr>
        <p:grpSpPr>
          <a:xfrm>
            <a:off x="4516585" y="1194985"/>
            <a:ext cx="1307821" cy="606631"/>
            <a:chOff x="2686658" y="2361294"/>
            <a:chExt cx="2093211" cy="1469083"/>
          </a:xfrm>
        </p:grpSpPr>
        <p:pic>
          <p:nvPicPr>
            <p:cNvPr id="37" name="图片 36">
              <a:extLst>
                <a:ext uri="{FF2B5EF4-FFF2-40B4-BE49-F238E27FC236}">
                  <a16:creationId xmlns:a16="http://schemas.microsoft.com/office/drawing/2014/main" xmlns="" id="{F57B80B4-5652-45A8-9734-74DE6264EE1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920" t="70617" r="43911" b="25950"/>
            <a:stretch/>
          </p:blipFill>
          <p:spPr>
            <a:xfrm>
              <a:off x="3284286" y="3304692"/>
              <a:ext cx="1108654" cy="451141"/>
            </a:xfrm>
            <a:prstGeom prst="rect">
              <a:avLst/>
            </a:prstGeom>
          </p:spPr>
        </p:pic>
        <p:pic>
          <p:nvPicPr>
            <p:cNvPr id="38" name="图片 37">
              <a:extLst>
                <a:ext uri="{FF2B5EF4-FFF2-40B4-BE49-F238E27FC236}">
                  <a16:creationId xmlns:a16="http://schemas.microsoft.com/office/drawing/2014/main" xmlns="" id="{EE36FFF2-3505-F1C3-D988-FA806CCDA1D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harpenSoften amount="2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872" t="34215" r="57301" b="62623"/>
            <a:stretch/>
          </p:blipFill>
          <p:spPr>
            <a:xfrm>
              <a:off x="3273374" y="2802196"/>
              <a:ext cx="1108654" cy="451141"/>
            </a:xfrm>
            <a:prstGeom prst="rect">
              <a:avLst/>
            </a:prstGeom>
          </p:spPr>
        </p:pic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xmlns="" id="{B157E7F7-BB4B-F134-49EB-29D603729C57}"/>
                </a:ext>
              </a:extLst>
            </p:cNvPr>
            <p:cNvSpPr txBox="1"/>
            <p:nvPr/>
          </p:nvSpPr>
          <p:spPr>
            <a:xfrm>
              <a:off x="2686658" y="2761738"/>
              <a:ext cx="1001811" cy="106863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63559">
                <a:defRPr/>
              </a:pPr>
              <a:r>
                <a:rPr lang="en-US" altLang="zh-CN" sz="756" b="1" i="1" dirty="0">
                  <a:solidFill>
                    <a:prstClr val="black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APX1</a:t>
              </a:r>
            </a:p>
            <a:p>
              <a:pPr defTabSz="863559">
                <a:defRPr/>
              </a:pPr>
              <a:endParaRPr lang="en-US" altLang="zh-CN" sz="756" b="1" i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endParaRPr>
            </a:p>
            <a:p>
              <a:pPr defTabSz="863559">
                <a:defRPr/>
              </a:pPr>
              <a:r>
                <a:rPr lang="en-US" altLang="zh-CN" sz="756" b="1" i="1" dirty="0">
                  <a:solidFill>
                    <a:prstClr val="black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ACT2</a:t>
              </a:r>
              <a:endParaRPr lang="en-US" altLang="zh-CN" sz="850" b="1" i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xmlns="" id="{99F2E332-F051-A69D-E14E-C4C4DC428163}"/>
                </a:ext>
              </a:extLst>
            </p:cNvPr>
            <p:cNvSpPr txBox="1"/>
            <p:nvPr/>
          </p:nvSpPr>
          <p:spPr>
            <a:xfrm>
              <a:off x="3230201" y="2361294"/>
              <a:ext cx="1549668" cy="5052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63559">
                <a:defRPr/>
              </a:pPr>
              <a:r>
                <a:rPr lang="en-US" altLang="zh-CN" sz="756" b="1" dirty="0">
                  <a:solidFill>
                    <a:prstClr val="black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Col-0     </a:t>
              </a:r>
              <a:r>
                <a:rPr lang="en-US" altLang="zh-CN" sz="756" b="1" i="1" dirty="0">
                  <a:solidFill>
                    <a:prstClr val="black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apx1-2</a:t>
              </a:r>
              <a:endParaRPr lang="zh-CN" altLang="en-US" sz="756" b="1" i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1" name="组合 40">
            <a:extLst>
              <a:ext uri="{FF2B5EF4-FFF2-40B4-BE49-F238E27FC236}">
                <a16:creationId xmlns:a16="http://schemas.microsoft.com/office/drawing/2014/main" xmlns="" id="{7D146B6F-F28B-AA18-1D14-B748C4E5CBA4}"/>
              </a:ext>
            </a:extLst>
          </p:cNvPr>
          <p:cNvGrpSpPr/>
          <p:nvPr/>
        </p:nvGrpSpPr>
        <p:grpSpPr>
          <a:xfrm>
            <a:off x="4486287" y="1849980"/>
            <a:ext cx="1319167" cy="606165"/>
            <a:chOff x="5097405" y="2426304"/>
            <a:chExt cx="2110809" cy="1439430"/>
          </a:xfrm>
        </p:grpSpPr>
        <p:pic>
          <p:nvPicPr>
            <p:cNvPr id="42" name="图片 41">
              <a:extLst>
                <a:ext uri="{FF2B5EF4-FFF2-40B4-BE49-F238E27FC236}">
                  <a16:creationId xmlns:a16="http://schemas.microsoft.com/office/drawing/2014/main" xmlns="" id="{E5B3A493-3F18-BB93-F6AF-C9618CDA815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sharpenSoften amount="50000"/>
                      </a14:imgEffect>
                      <a14:imgEffect>
                        <a14:brightnessContrast bright="20000" contrast="20000"/>
                      </a14:imgEffect>
                    </a14:imgLayer>
                  </a14:imgProps>
                </a:ext>
              </a:extLst>
            </a:blip>
            <a:srcRect l="58942" t="12263" b="26750"/>
            <a:stretch/>
          </p:blipFill>
          <p:spPr>
            <a:xfrm>
              <a:off x="5743354" y="3304644"/>
              <a:ext cx="1128689" cy="451143"/>
            </a:xfrm>
            <a:prstGeom prst="rect">
              <a:avLst/>
            </a:prstGeom>
          </p:spPr>
        </p:pic>
        <p:pic>
          <p:nvPicPr>
            <p:cNvPr id="43" name="图片 42">
              <a:extLst>
                <a:ext uri="{FF2B5EF4-FFF2-40B4-BE49-F238E27FC236}">
                  <a16:creationId xmlns:a16="http://schemas.microsoft.com/office/drawing/2014/main" xmlns="" id="{C9813238-9ADD-E0DD-1200-8FB2765519D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66780" t="-1744"/>
            <a:stretch/>
          </p:blipFill>
          <p:spPr>
            <a:xfrm>
              <a:off x="5743354" y="2802193"/>
              <a:ext cx="1128689" cy="451142"/>
            </a:xfrm>
            <a:prstGeom prst="rect">
              <a:avLst/>
            </a:prstGeom>
          </p:spPr>
        </p:pic>
        <p:sp>
          <p:nvSpPr>
            <p:cNvPr id="44" name="文本框 43">
              <a:extLst>
                <a:ext uri="{FF2B5EF4-FFF2-40B4-BE49-F238E27FC236}">
                  <a16:creationId xmlns:a16="http://schemas.microsoft.com/office/drawing/2014/main" xmlns="" id="{29E43EA0-6706-D856-ACDA-BE5D5CC035B7}"/>
                </a:ext>
              </a:extLst>
            </p:cNvPr>
            <p:cNvSpPr txBox="1"/>
            <p:nvPr/>
          </p:nvSpPr>
          <p:spPr>
            <a:xfrm>
              <a:off x="5097405" y="2817860"/>
              <a:ext cx="815223" cy="104787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defTabSz="863559">
                <a:defRPr/>
              </a:pPr>
              <a:r>
                <a:rPr lang="en-US" altLang="zh-CN" sz="756" b="1" i="1" dirty="0">
                  <a:solidFill>
                    <a:prstClr val="black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APX1</a:t>
              </a:r>
            </a:p>
            <a:p>
              <a:pPr defTabSz="863559">
                <a:defRPr/>
              </a:pPr>
              <a:endParaRPr lang="en-US" altLang="zh-CN" sz="756" b="1" i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endParaRPr>
            </a:p>
            <a:p>
              <a:pPr defTabSz="863559">
                <a:defRPr/>
              </a:pPr>
              <a:r>
                <a:rPr lang="en-US" altLang="zh-CN" sz="756" b="1" i="1" dirty="0">
                  <a:solidFill>
                    <a:prstClr val="black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ACT2</a:t>
              </a:r>
              <a:endParaRPr lang="en-US" altLang="zh-CN" sz="850" b="1" i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45" name="文本框 44">
              <a:extLst>
                <a:ext uri="{FF2B5EF4-FFF2-40B4-BE49-F238E27FC236}">
                  <a16:creationId xmlns:a16="http://schemas.microsoft.com/office/drawing/2014/main" xmlns="" id="{C346E5B9-C352-8FDB-C008-6D5F271466E2}"/>
                </a:ext>
              </a:extLst>
            </p:cNvPr>
            <p:cNvSpPr txBox="1"/>
            <p:nvPr/>
          </p:nvSpPr>
          <p:spPr>
            <a:xfrm>
              <a:off x="5658547" y="2426304"/>
              <a:ext cx="1549667" cy="49546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defTabSz="863559">
                <a:defRPr/>
              </a:pPr>
              <a:r>
                <a:rPr lang="en-US" altLang="zh-CN" sz="756" b="1" dirty="0">
                  <a:solidFill>
                    <a:prstClr val="black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Col-0    </a:t>
              </a:r>
              <a:r>
                <a:rPr lang="en-US" altLang="zh-CN" sz="756" b="1" i="1" dirty="0">
                  <a:solidFill>
                    <a:prstClr val="black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apx1-6</a:t>
              </a:r>
              <a:endParaRPr lang="zh-CN" altLang="en-US" sz="756" b="1" i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  <p:sp>
        <p:nvSpPr>
          <p:cNvPr id="46" name="文本框 45">
            <a:extLst>
              <a:ext uri="{FF2B5EF4-FFF2-40B4-BE49-F238E27FC236}">
                <a16:creationId xmlns:a16="http://schemas.microsoft.com/office/drawing/2014/main" xmlns="" id="{E00D4A2C-675D-6947-4AD6-A196B60E2FE7}"/>
              </a:ext>
            </a:extLst>
          </p:cNvPr>
          <p:cNvSpPr txBox="1"/>
          <p:nvPr/>
        </p:nvSpPr>
        <p:spPr>
          <a:xfrm>
            <a:off x="467772" y="1003969"/>
            <a:ext cx="485363" cy="2376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06348">
              <a:defRPr/>
            </a:pPr>
            <a:r>
              <a:rPr lang="en-US" altLang="zh-CN" sz="944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A)</a:t>
            </a:r>
            <a:endParaRPr lang="zh-CN" altLang="en-US" sz="944" dirty="0">
              <a:solidFill>
                <a:prstClr val="black"/>
              </a:solidFill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xmlns="" id="{EC6DAF64-FE2A-46A1-8FD1-4C5E13681C75}"/>
              </a:ext>
            </a:extLst>
          </p:cNvPr>
          <p:cNvSpPr txBox="1"/>
          <p:nvPr/>
        </p:nvSpPr>
        <p:spPr>
          <a:xfrm>
            <a:off x="2180169" y="941077"/>
            <a:ext cx="485363" cy="2376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06348">
              <a:defRPr/>
            </a:pPr>
            <a:r>
              <a:rPr lang="en-US" altLang="zh-CN" sz="944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B)</a:t>
            </a:r>
            <a:endParaRPr lang="zh-CN" altLang="en-US" sz="944" dirty="0">
              <a:solidFill>
                <a:prstClr val="black"/>
              </a:solidFill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xmlns="" id="{8317C736-2DE6-4185-3F30-1D343DFADE1D}"/>
              </a:ext>
            </a:extLst>
          </p:cNvPr>
          <p:cNvSpPr txBox="1"/>
          <p:nvPr/>
        </p:nvSpPr>
        <p:spPr>
          <a:xfrm>
            <a:off x="4132122" y="911787"/>
            <a:ext cx="485363" cy="2376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06348">
              <a:defRPr/>
            </a:pPr>
            <a:r>
              <a:rPr lang="en-US" altLang="zh-CN" sz="944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C)</a:t>
            </a:r>
            <a:endParaRPr lang="zh-CN" altLang="en-US" sz="944" dirty="0">
              <a:solidFill>
                <a:prstClr val="black"/>
              </a:solidFill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xmlns="" id="{176D880F-1D66-710C-D5AB-5334C13D0BAB}"/>
              </a:ext>
            </a:extLst>
          </p:cNvPr>
          <p:cNvSpPr txBox="1"/>
          <p:nvPr/>
        </p:nvSpPr>
        <p:spPr>
          <a:xfrm>
            <a:off x="372663" y="3333016"/>
            <a:ext cx="5374486" cy="81035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defRPr/>
            </a:pPr>
            <a:r>
              <a:rPr lang="en-US" altLang="zh-CN" sz="1133" b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</a:t>
            </a:r>
            <a:r>
              <a:rPr lang="en-US" altLang="zh-CN" sz="1133" b="1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</a:t>
            </a:r>
            <a:r>
              <a:rPr lang="en-US" altLang="zh-CN" sz="1133" b="1" smtClean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2</a:t>
            </a:r>
            <a:r>
              <a:rPr lang="en-US" altLang="zh-CN" sz="1133" b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13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of AtAPX1 and AtBKI1 </a:t>
            </a:r>
            <a:r>
              <a:rPr lang="en-US" altLang="zh-CN" sz="1133" b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in Arabidopsis. </a:t>
            </a:r>
            <a:r>
              <a:rPr lang="en-US" altLang="zh-CN" sz="1133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A)</a:t>
            </a:r>
            <a:r>
              <a:rPr lang="en-US" altLang="zh-CN" sz="1133" dirty="0">
                <a:solidFill>
                  <a:srgbClr val="2A2B2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33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estern blot of AtAPX1 over expression line</a:t>
            </a:r>
            <a:r>
              <a:rPr lang="en-US" altLang="zh-C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with anti-GFP antibody</a:t>
            </a:r>
            <a:r>
              <a:rPr lang="en-US" altLang="zh-CN" sz="1133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sz="1133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B</a:t>
            </a:r>
            <a:r>
              <a:rPr lang="en-US" altLang="zh-CN" sz="1133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Western blot of AtBKI1 over expression line</a:t>
            </a:r>
            <a:r>
              <a:rPr lang="en-US" altLang="zh-C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with anti-Flag antibody</a:t>
            </a:r>
            <a:r>
              <a:rPr lang="en-US" altLang="zh-CN" sz="1133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 </a:t>
            </a:r>
            <a:r>
              <a:rPr lang="en-US" altLang="zh-CN" sz="1133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C</a:t>
            </a:r>
            <a:r>
              <a:rPr lang="en-US" altLang="zh-CN" sz="1133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altLang="zh-CN" sz="1133" dirty="0">
                <a:solidFill>
                  <a:srgbClr val="2A2B2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dentification of </a:t>
            </a:r>
            <a:r>
              <a:rPr lang="en-US" altLang="zh-CN" sz="1133" i="1" dirty="0">
                <a:solidFill>
                  <a:srgbClr val="2A2B2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px1 </a:t>
            </a:r>
            <a:r>
              <a:rPr lang="en-US" altLang="zh-CN" sz="1133" dirty="0">
                <a:solidFill>
                  <a:srgbClr val="2A2B2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utants</a:t>
            </a:r>
            <a:r>
              <a:rPr lang="en-US" altLang="zh-CN" sz="1133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by semi-RT PCR.</a:t>
            </a:r>
            <a:r>
              <a:rPr lang="en-US" altLang="zh-CN" sz="1133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altLang="zh-CN" sz="1133" dirty="0">
              <a:solidFill>
                <a:prstClr val="black"/>
              </a:solidFill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grpSp>
        <p:nvGrpSpPr>
          <p:cNvPr id="19" name="组合 18">
            <a:extLst>
              <a:ext uri="{FF2B5EF4-FFF2-40B4-BE49-F238E27FC236}">
                <a16:creationId xmlns:a16="http://schemas.microsoft.com/office/drawing/2014/main" xmlns="" id="{0291BF9D-9A7E-77BD-F952-84E5C3A2B36B}"/>
              </a:ext>
            </a:extLst>
          </p:cNvPr>
          <p:cNvGrpSpPr/>
          <p:nvPr/>
        </p:nvGrpSpPr>
        <p:grpSpPr>
          <a:xfrm>
            <a:off x="413887" y="1276051"/>
            <a:ext cx="2223201" cy="1269513"/>
            <a:chOff x="1477871" y="2426168"/>
            <a:chExt cx="3669173" cy="2557561"/>
          </a:xfrm>
        </p:grpSpPr>
        <p:pic>
          <p:nvPicPr>
            <p:cNvPr id="20" name="图片 19">
              <a:extLst>
                <a:ext uri="{FF2B5EF4-FFF2-40B4-BE49-F238E27FC236}">
                  <a16:creationId xmlns:a16="http://schemas.microsoft.com/office/drawing/2014/main" xmlns="" id="{C85BAA97-3208-BB41-1252-9E9C6F74FE7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526" t="50062" r="48554" b="36607"/>
            <a:stretch/>
          </p:blipFill>
          <p:spPr>
            <a:xfrm>
              <a:off x="2445562" y="2879002"/>
              <a:ext cx="1333772" cy="728029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</p:pic>
        <p:pic>
          <p:nvPicPr>
            <p:cNvPr id="21" name="图片 20">
              <a:extLst>
                <a:ext uri="{FF2B5EF4-FFF2-40B4-BE49-F238E27FC236}">
                  <a16:creationId xmlns:a16="http://schemas.microsoft.com/office/drawing/2014/main" xmlns="" id="{E4C51CFF-30DE-9372-7DA5-84BD0CB14CC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650" t="47592" r="29198" b="44139"/>
            <a:stretch/>
          </p:blipFill>
          <p:spPr>
            <a:xfrm>
              <a:off x="2441788" y="3881055"/>
              <a:ext cx="1337546" cy="528456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cxnSp>
          <p:nvCxnSpPr>
            <p:cNvPr id="22" name="直接连接符 21">
              <a:extLst>
                <a:ext uri="{FF2B5EF4-FFF2-40B4-BE49-F238E27FC236}">
                  <a16:creationId xmlns:a16="http://schemas.microsoft.com/office/drawing/2014/main" xmlns="" id="{38EEDB5E-4512-4740-51A6-168CDBD2303F}"/>
                </a:ext>
              </a:extLst>
            </p:cNvPr>
            <p:cNvCxnSpPr>
              <a:cxnSpLocks/>
            </p:cNvCxnSpPr>
            <p:nvPr/>
          </p:nvCxnSpPr>
          <p:spPr>
            <a:xfrm>
              <a:off x="2228461" y="3616959"/>
              <a:ext cx="20193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" name="直接连接符 22">
              <a:extLst>
                <a:ext uri="{FF2B5EF4-FFF2-40B4-BE49-F238E27FC236}">
                  <a16:creationId xmlns:a16="http://schemas.microsoft.com/office/drawing/2014/main" xmlns="" id="{2A05DE9D-1303-4C7A-ED9B-FCAD80E12E03}"/>
                </a:ext>
              </a:extLst>
            </p:cNvPr>
            <p:cNvCxnSpPr>
              <a:cxnSpLocks/>
            </p:cNvCxnSpPr>
            <p:nvPr/>
          </p:nvCxnSpPr>
          <p:spPr>
            <a:xfrm>
              <a:off x="2209281" y="2915920"/>
              <a:ext cx="20193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4" name="直接连接符 23">
              <a:extLst>
                <a:ext uri="{FF2B5EF4-FFF2-40B4-BE49-F238E27FC236}">
                  <a16:creationId xmlns:a16="http://schemas.microsoft.com/office/drawing/2014/main" xmlns="" id="{BF701841-1286-39F7-0C88-E94559E470E9}"/>
                </a:ext>
              </a:extLst>
            </p:cNvPr>
            <p:cNvCxnSpPr>
              <a:cxnSpLocks/>
            </p:cNvCxnSpPr>
            <p:nvPr/>
          </p:nvCxnSpPr>
          <p:spPr>
            <a:xfrm>
              <a:off x="2216525" y="3962399"/>
              <a:ext cx="20193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5" name="直接连接符 24">
              <a:extLst>
                <a:ext uri="{FF2B5EF4-FFF2-40B4-BE49-F238E27FC236}">
                  <a16:creationId xmlns:a16="http://schemas.microsoft.com/office/drawing/2014/main" xmlns="" id="{95AA7893-942C-EF8E-A4E6-D30A73A8147D}"/>
                </a:ext>
              </a:extLst>
            </p:cNvPr>
            <p:cNvCxnSpPr>
              <a:cxnSpLocks/>
            </p:cNvCxnSpPr>
            <p:nvPr/>
          </p:nvCxnSpPr>
          <p:spPr>
            <a:xfrm>
              <a:off x="2218300" y="4389121"/>
              <a:ext cx="20193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xmlns="" id="{ED2DC83E-40CD-B199-B44D-52DAF56944C9}"/>
                </a:ext>
              </a:extLst>
            </p:cNvPr>
            <p:cNvSpPr txBox="1"/>
            <p:nvPr/>
          </p:nvSpPr>
          <p:spPr>
            <a:xfrm>
              <a:off x="1888491" y="2426168"/>
              <a:ext cx="629920" cy="4203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56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</a:t>
              </a:r>
              <a:endParaRPr lang="zh-CN" altLang="en-US" sz="756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xmlns="" id="{AD7894A7-5638-3AEB-8969-D9C97F5C47A8}"/>
                </a:ext>
              </a:extLst>
            </p:cNvPr>
            <p:cNvSpPr txBox="1"/>
            <p:nvPr/>
          </p:nvSpPr>
          <p:spPr>
            <a:xfrm>
              <a:off x="1881548" y="2687786"/>
              <a:ext cx="558799" cy="4203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56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5</a:t>
              </a:r>
              <a:endParaRPr lang="zh-CN" altLang="en-US" sz="756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xmlns="" id="{CB1D3A87-C4A7-E197-8684-8DFF615D2902}"/>
                </a:ext>
              </a:extLst>
            </p:cNvPr>
            <p:cNvSpPr txBox="1"/>
            <p:nvPr/>
          </p:nvSpPr>
          <p:spPr>
            <a:xfrm>
              <a:off x="1907413" y="3748500"/>
              <a:ext cx="558799" cy="4203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56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endParaRPr lang="zh-CN" altLang="en-US" sz="756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xmlns="" id="{7EE4A9AF-EE8F-BC2A-A6F5-02513AD6A1C3}"/>
                </a:ext>
              </a:extLst>
            </p:cNvPr>
            <p:cNvSpPr txBox="1"/>
            <p:nvPr/>
          </p:nvSpPr>
          <p:spPr>
            <a:xfrm>
              <a:off x="1876454" y="3398636"/>
              <a:ext cx="558799" cy="4203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56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7</a:t>
              </a:r>
              <a:endParaRPr lang="zh-CN" altLang="en-US" sz="756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xmlns="" id="{52D8C2F2-11FC-00A3-E9C6-5D25F889B21F}"/>
                </a:ext>
              </a:extLst>
            </p:cNvPr>
            <p:cNvSpPr txBox="1"/>
            <p:nvPr/>
          </p:nvSpPr>
          <p:spPr>
            <a:xfrm>
              <a:off x="1911755" y="4182104"/>
              <a:ext cx="558799" cy="4203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56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7</a:t>
              </a:r>
              <a:endParaRPr lang="zh-CN" altLang="en-US" sz="756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xmlns="" id="{BB45B295-8912-0FAA-09A8-8C36611AE97B}"/>
                </a:ext>
              </a:extLst>
            </p:cNvPr>
            <p:cNvSpPr txBox="1"/>
            <p:nvPr/>
          </p:nvSpPr>
          <p:spPr>
            <a:xfrm>
              <a:off x="3861174" y="3954146"/>
              <a:ext cx="1148082" cy="4203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56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α-Actin</a:t>
              </a:r>
              <a:endParaRPr lang="zh-CN" altLang="en-US" sz="756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xmlns="" id="{E228F79E-6055-C12A-1058-CB07177794AB}"/>
                </a:ext>
              </a:extLst>
            </p:cNvPr>
            <p:cNvSpPr txBox="1"/>
            <p:nvPr/>
          </p:nvSpPr>
          <p:spPr>
            <a:xfrm>
              <a:off x="3866886" y="3067164"/>
              <a:ext cx="1280158" cy="4203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56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α-GFP</a:t>
              </a:r>
              <a:endParaRPr lang="zh-CN" altLang="en-US" sz="756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xmlns="" id="{02F20950-772E-9A84-58F2-94C3C10AE94C}"/>
                </a:ext>
              </a:extLst>
            </p:cNvPr>
            <p:cNvSpPr txBox="1"/>
            <p:nvPr/>
          </p:nvSpPr>
          <p:spPr>
            <a:xfrm rot="19440000">
              <a:off x="1477871" y="4563389"/>
              <a:ext cx="2236470" cy="4203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56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tAPX1-GFP #19</a:t>
              </a:r>
              <a:endParaRPr lang="zh-CN" altLang="en-US" sz="756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xmlns="" id="{A342270D-081A-1A5C-6EF2-F2CF46352C93}"/>
                </a:ext>
              </a:extLst>
            </p:cNvPr>
            <p:cNvSpPr txBox="1"/>
            <p:nvPr/>
          </p:nvSpPr>
          <p:spPr>
            <a:xfrm rot="19440000">
              <a:off x="2495734" y="4509287"/>
              <a:ext cx="2236470" cy="4203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56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tAPX1-GFP #7</a:t>
              </a:r>
              <a:endParaRPr lang="zh-CN" altLang="en-US" sz="756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xmlns="" id="{64D56353-7A2F-6C55-4CEE-C38B463FA0FF}"/>
                </a:ext>
              </a:extLst>
            </p:cNvPr>
            <p:cNvSpPr txBox="1"/>
            <p:nvPr/>
          </p:nvSpPr>
          <p:spPr>
            <a:xfrm rot="19440000">
              <a:off x="1955660" y="4560840"/>
              <a:ext cx="2236470" cy="4203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56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tAPX1-GFP #13</a:t>
              </a:r>
              <a:endParaRPr lang="zh-CN" altLang="en-US" sz="756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175497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100</Words>
  <Application>Microsoft Office PowerPoint</Application>
  <PresentationFormat>Custom</PresentationFormat>
  <Paragraphs>3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等线</vt:lpstr>
      <vt:lpstr>等线 Light</vt:lpstr>
      <vt:lpstr>Arial</vt:lpstr>
      <vt:lpstr>Calibri</vt:lpstr>
      <vt:lpstr>Calibri Light</vt:lpstr>
      <vt:lpstr>Times New Roman</vt:lpstr>
      <vt:lpstr>Office 主题​​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79984</dc:creator>
  <cp:lastModifiedBy>MDPI</cp:lastModifiedBy>
  <cp:revision>6</cp:revision>
  <dcterms:created xsi:type="dcterms:W3CDTF">2022-12-15T02:33:21Z</dcterms:created>
  <dcterms:modified xsi:type="dcterms:W3CDTF">2023-03-07T10:58:28Z</dcterms:modified>
</cp:coreProperties>
</file>